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14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94" userDrawn="1">
          <p15:clr>
            <a:srgbClr val="A4A3A4"/>
          </p15:clr>
        </p15:guide>
        <p15:guide id="3" orient="horz" pos="759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1A65936-B12E-74C1-3A5C-ED7BB864E18C}" name="Christof Bernemann" initials="CB" userId="S::christof.bernemann@wwum.onmicrosoft.com::078ee18b-a8b2-4b63-8f7f-709e1bd760ea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Wüstmann, Neele Elisabeth" initials="WNE" lastIdx="9" clrIdx="0">
    <p:extLst>
      <p:ext uri="{19B8F6BF-5375-455C-9EA6-DF929625EA0E}">
        <p15:presenceInfo xmlns:p15="http://schemas.microsoft.com/office/powerpoint/2012/main" userId="S-1-5-21-1659004503-1708537768-1343024091-12411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0FF"/>
    <a:srgbClr val="B98DEF"/>
    <a:srgbClr val="F41914"/>
    <a:srgbClr val="FFCDB3"/>
    <a:srgbClr val="FFA071"/>
    <a:srgbClr val="CEAEF4"/>
    <a:srgbClr val="E9B4E2"/>
    <a:srgbClr val="DB85CF"/>
    <a:srgbClr val="FCFDCA"/>
    <a:srgbClr val="F7FA8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5522" autoAdjust="0"/>
    <p:restoredTop sz="94660"/>
  </p:normalViewPr>
  <p:slideViewPr>
    <p:cSldViewPr snapToGrid="0" showGuides="1">
      <p:cViewPr>
        <p:scale>
          <a:sx n="88" d="100"/>
          <a:sy n="88" d="100"/>
        </p:scale>
        <p:origin x="6616" y="1712"/>
      </p:cViewPr>
      <p:guideLst>
        <p:guide pos="294"/>
        <p:guide orient="horz" pos="75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01E81C-BC0D-1A49-B98C-5116AAABDB4F}" type="datetimeFigureOut">
              <a:rPr lang="de-DE" smtClean="0"/>
              <a:t>12.06.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5535BD-E74C-6640-B460-C86A058A61F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14643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7417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272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3435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39794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62806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70235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9334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5780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2212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9056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8126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9691A-C684-4ED0-A329-5821C2ADA0A5}" type="datetimeFigureOut">
              <a:rPr lang="en-GB" smtClean="0"/>
              <a:t>12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38113A-EE40-4857-B1AF-70D39CE0AE67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82051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A073F1F5-F84B-CC98-574C-093B4EB45238}"/>
              </a:ext>
            </a:extLst>
          </p:cNvPr>
          <p:cNvSpPr txBox="1"/>
          <p:nvPr/>
        </p:nvSpPr>
        <p:spPr>
          <a:xfrm>
            <a:off x="406330" y="3287816"/>
            <a:ext cx="6093885" cy="31700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RCh38	TTCAGAATGAACAAATTAAAAGAATCA</a:t>
            </a:r>
            <a:r>
              <a:rPr lang="en-US" sz="1000" b="1" u="sng" kern="10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AA</a:t>
            </a:r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CAGACACTAACCCCAAGCCATACTGCATGGCA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49580" indent="449580"/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|||||||||||||||||||||||||||---|||||||||||||||||||||||||||||||||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22Rv1		TTCAGAATGAACAAATTAAAAGAATCA---TCAGACACTAACCCCAAGCCATACTGCATGGCA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49580" indent="449580"/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|||||||||||||||||||||||||||---|||||||||||||||||||||||||||||||||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LNCaP		TTCAGAATGAACAAATTAAAAGAATCA</a:t>
            </a:r>
            <a:r>
              <a:rPr lang="en-US" sz="1000" b="1" kern="10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AA</a:t>
            </a:r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CAGACACTAACCCCAAGCCATACTGCATGGCA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49580" indent="449580"/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|||||||||||||||||||||||||||||||||||||||||||||||||||||||||||||||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VCaP 		TTCAGAATGAACAAATTAAAAGAATCA</a:t>
            </a:r>
            <a:r>
              <a:rPr lang="en-US" sz="1000" b="1" kern="10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AA</a:t>
            </a:r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CAGACACTAACCCCAAGCCATACTGCATGGCA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49580" indent="449580"/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|||||||||||||||||||||||||||||||||||||||||||||||||||||||||||||||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PC-3 		TTCAGAATGAACAAATTAAAAGAATCA</a:t>
            </a:r>
            <a:r>
              <a:rPr lang="en-US" sz="1000" b="1" kern="10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AA</a:t>
            </a:r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CAGACACTAACCCCAAGCCATACTGCATGGCA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49580" indent="449580"/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|||||||||||||||||||||||||||||||||||||||||||||||||||||||||||||||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U-145 	TTCAGAATGAACAAATTAAAAGAATCA</a:t>
            </a:r>
            <a:r>
              <a:rPr lang="en-US" sz="1000" b="1" kern="10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AA</a:t>
            </a:r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CAGACACTAACCCCAAGCCATACTGCATGGCA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49580" indent="449580"/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|||||||||||||||||||||||||||||||||||||||||||||||||||||||||||||||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RWPE-1 	TTCAGAATGAACAAATTAAAAGAATCA</a:t>
            </a:r>
            <a:r>
              <a:rPr lang="en-US" sz="1000" b="1" kern="10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AA</a:t>
            </a:r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CAGACACTAACCCCAAGCCATACTGCATGGCA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49580" indent="449580"/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|||||||||||||||||||||||||||||||||||||||||||||||||||||||||||||||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MS-pPC-191	TTCAGAATGAACAAATTAAAAGAATCA</a:t>
            </a:r>
            <a:r>
              <a:rPr lang="en-US" sz="1000" b="1" kern="10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AA</a:t>
            </a:r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CAGACACTAACCCCAAGCCATACTGCATGGCA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49580" indent="449580"/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|||||||||||||||||||||||||||||||||||||||||||||||||||||||||||||||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MS-pPC-192	TTCAGAATGAACAAATTAAAAGAATCA</a:t>
            </a:r>
            <a:r>
              <a:rPr lang="en-US" sz="1000" b="1" kern="10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AA</a:t>
            </a:r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CAGACACTAACCCCAAGCCATACTGCATGGCA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449580" indent="449580"/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|||||||||||||||||||||||||||||||||||||||||||||||||||||||||||||||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MS-pPC-1933	TTCAGAATGAACAAATTAAAAGAATCA</a:t>
            </a:r>
            <a:r>
              <a:rPr lang="en-US" sz="1000" b="1" kern="100" dirty="0">
                <a:solidFill>
                  <a:srgbClr val="FF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AA</a:t>
            </a:r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CAGACACTAACCCCAAGCCATACTGCATGGCA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000" kern="100" dirty="0">
                <a:effectLst/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de-DE" sz="10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DACA999B-249D-5342-1051-47BBCD0B422D}"/>
              </a:ext>
            </a:extLst>
          </p:cNvPr>
          <p:cNvSpPr txBox="1"/>
          <p:nvPr/>
        </p:nvSpPr>
        <p:spPr>
          <a:xfrm>
            <a:off x="252873" y="105288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0FAF12FC-17C2-51E5-89AE-3AD0EF75C3F8}"/>
              </a:ext>
            </a:extLst>
          </p:cNvPr>
          <p:cNvSpPr txBox="1"/>
          <p:nvPr/>
        </p:nvSpPr>
        <p:spPr>
          <a:xfrm>
            <a:off x="392980" y="2211206"/>
            <a:ext cx="6097162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914400"/>
            <a:r>
              <a:rPr lang="de-DE" sz="1000" dirty="0">
                <a:solidFill>
                  <a:prstClr val="black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ttgttcatat</a:t>
            </a:r>
            <a:r>
              <a:rPr lang="de-DE" sz="1000" b="1" u="sng" dirty="0">
                <a:solidFill>
                  <a:prstClr val="black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ggtcctgcattaacaccatat</a:t>
            </a:r>
            <a:r>
              <a:rPr lang="de-DE" sz="1000" dirty="0">
                <a:solidFill>
                  <a:prstClr val="black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atataaagtgtgagaaatactacattcttcaggattctctgtaggttaacaatgaagatgatgactcaaccctttctttgtttgcataatgtgatgccactaatagtgggtaacttctctgccttacctcctctgttccaaacag</a:t>
            </a:r>
            <a:r>
              <a:rPr lang="en-US" sz="1000" dirty="0">
                <a:solidFill>
                  <a:srgbClr val="555555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GATTTTTCAGAATGAACAAATTAAAAGAATCA</a:t>
            </a:r>
            <a:r>
              <a:rPr lang="en-US" sz="1000" b="1" u="sng" dirty="0">
                <a:solidFill>
                  <a:srgbClr val="FF0000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AA</a:t>
            </a:r>
            <a:r>
              <a:rPr lang="en-US" sz="1000" dirty="0">
                <a:solidFill>
                  <a:srgbClr val="555555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CAGACACTAACCCCAAGCCATACTGCATGGCAGCACCAATGGGACTGACAGAAAACAACAGAAATAGGAAGAAATCCTACAGAGAAACAAACT</a:t>
            </a:r>
            <a:r>
              <a:rPr lang="en-US" sz="1000" b="1" u="sng" dirty="0">
                <a:solidFill>
                  <a:srgbClr val="555555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GAAAGCTGTCTCATGGCCT</a:t>
            </a:r>
            <a:r>
              <a:rPr lang="en-US" sz="1000" dirty="0">
                <a:solidFill>
                  <a:srgbClr val="555555"/>
                </a:solidFill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TTGAATCATA</a:t>
            </a:r>
            <a:r>
              <a:rPr lang="de-DE" sz="1000" dirty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6084C0BB-5109-267F-A62D-14E9F99DEE36}"/>
              </a:ext>
            </a:extLst>
          </p:cNvPr>
          <p:cNvSpPr/>
          <p:nvPr/>
        </p:nvSpPr>
        <p:spPr>
          <a:xfrm>
            <a:off x="2790604" y="1577072"/>
            <a:ext cx="204112" cy="180996"/>
          </a:xfrm>
          <a:prstGeom prst="rect">
            <a:avLst/>
          </a:prstGeom>
          <a:solidFill>
            <a:srgbClr val="CEAEF4"/>
          </a:solidFill>
          <a:ln w="9525" cap="flat" cmpd="sng" algn="ctr">
            <a:solidFill>
              <a:srgbClr val="B98DEF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400"/>
            <a:r>
              <a:rPr lang="de-DE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id="{EE8C7F75-A202-7B92-97DC-21D0C0764217}"/>
              </a:ext>
            </a:extLst>
          </p:cNvPr>
          <p:cNvSpPr/>
          <p:nvPr/>
        </p:nvSpPr>
        <p:spPr>
          <a:xfrm>
            <a:off x="3872749" y="1577072"/>
            <a:ext cx="157113" cy="180996"/>
          </a:xfrm>
          <a:prstGeom prst="rect">
            <a:avLst/>
          </a:prstGeom>
          <a:solidFill>
            <a:srgbClr val="CEAEF4"/>
          </a:solidFill>
          <a:ln w="9525" cap="flat" cmpd="sng" algn="ctr">
            <a:solidFill>
              <a:srgbClr val="B98DEF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algn="ctr" defTabSz="914400"/>
            <a:r>
              <a:rPr lang="de-DE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grpSp>
        <p:nvGrpSpPr>
          <p:cNvPr id="11" name="Gruppieren 10">
            <a:extLst>
              <a:ext uri="{FF2B5EF4-FFF2-40B4-BE49-F238E27FC236}">
                <a16:creationId xmlns:a16="http://schemas.microsoft.com/office/drawing/2014/main" id="{7C9ECABA-2235-7D98-B5E3-F033DBAFBEEC}"/>
              </a:ext>
            </a:extLst>
          </p:cNvPr>
          <p:cNvGrpSpPr/>
          <p:nvPr/>
        </p:nvGrpSpPr>
        <p:grpSpPr>
          <a:xfrm>
            <a:off x="3240150" y="1496990"/>
            <a:ext cx="381368" cy="261078"/>
            <a:chOff x="3474842" y="1222055"/>
            <a:chExt cx="381368" cy="261078"/>
          </a:xfrm>
        </p:grpSpPr>
        <p:sp>
          <p:nvSpPr>
            <p:cNvPr id="12" name="Rechteck 11">
              <a:extLst>
                <a:ext uri="{FF2B5EF4-FFF2-40B4-BE49-F238E27FC236}">
                  <a16:creationId xmlns:a16="http://schemas.microsoft.com/office/drawing/2014/main" id="{8FB5413E-0766-B72B-46F3-FB9C05FC7551}"/>
                </a:ext>
              </a:extLst>
            </p:cNvPr>
            <p:cNvSpPr/>
            <p:nvPr/>
          </p:nvSpPr>
          <p:spPr>
            <a:xfrm>
              <a:off x="3474842" y="1302137"/>
              <a:ext cx="381368" cy="180996"/>
            </a:xfrm>
            <a:prstGeom prst="rect">
              <a:avLst/>
            </a:prstGeom>
            <a:solidFill>
              <a:srgbClr val="FFCDB3"/>
            </a:solidFill>
            <a:ln w="9525" cap="flat" cmpd="sng" algn="ctr">
              <a:solidFill>
                <a:srgbClr val="FFA071"/>
              </a:solidFill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algn="ctr" defTabSz="914400"/>
              <a:r>
                <a:rPr lang="de-DE" sz="800" kern="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4</a:t>
              </a:r>
            </a:p>
          </p:txBody>
        </p:sp>
        <p:sp>
          <p:nvSpPr>
            <p:cNvPr id="13" name="Dreieck 39">
              <a:extLst>
                <a:ext uri="{FF2B5EF4-FFF2-40B4-BE49-F238E27FC236}">
                  <a16:creationId xmlns:a16="http://schemas.microsoft.com/office/drawing/2014/main" id="{BE6A8AB0-AD38-0F45-F02B-76618FFA1A3B}"/>
                </a:ext>
              </a:extLst>
            </p:cNvPr>
            <p:cNvSpPr/>
            <p:nvPr/>
          </p:nvSpPr>
          <p:spPr>
            <a:xfrm rot="10800000">
              <a:off x="3517820" y="1222055"/>
              <a:ext cx="78557" cy="69653"/>
            </a:xfrm>
            <a:prstGeom prst="triangle">
              <a:avLst/>
            </a:prstGeom>
            <a:solidFill>
              <a:sysClr val="windowText" lastClr="000000"/>
            </a:solidFill>
            <a:ln w="19050" cap="flat" cmpd="sng" algn="ctr">
              <a:noFill/>
              <a:prstDash val="solid"/>
              <a:miter lim="800000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800" b="0" i="0" u="none" strike="noStrike" kern="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4" name="Gerade Verbindung 20">
            <a:extLst>
              <a:ext uri="{FF2B5EF4-FFF2-40B4-BE49-F238E27FC236}">
                <a16:creationId xmlns:a16="http://schemas.microsoft.com/office/drawing/2014/main" id="{DD6DF694-A768-9BEA-EDEC-56F066F86F71}"/>
              </a:ext>
            </a:extLst>
          </p:cNvPr>
          <p:cNvCxnSpPr>
            <a:cxnSpLocks/>
          </p:cNvCxnSpPr>
          <p:nvPr/>
        </p:nvCxnSpPr>
        <p:spPr>
          <a:xfrm>
            <a:off x="3002291" y="1671856"/>
            <a:ext cx="238090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ysDot"/>
            <a:miter lim="800000"/>
          </a:ln>
          <a:effectLst/>
        </p:spPr>
      </p:cxnSp>
      <p:cxnSp>
        <p:nvCxnSpPr>
          <p:cNvPr id="15" name="Gerade Verbindung 21">
            <a:extLst>
              <a:ext uri="{FF2B5EF4-FFF2-40B4-BE49-F238E27FC236}">
                <a16:creationId xmlns:a16="http://schemas.microsoft.com/office/drawing/2014/main" id="{4D28E7D4-AE54-6F72-6D3E-7E6230212903}"/>
              </a:ext>
            </a:extLst>
          </p:cNvPr>
          <p:cNvCxnSpPr>
            <a:cxnSpLocks/>
          </p:cNvCxnSpPr>
          <p:nvPr/>
        </p:nvCxnSpPr>
        <p:spPr>
          <a:xfrm>
            <a:off x="3629469" y="1671855"/>
            <a:ext cx="236604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ysDot"/>
            <a:miter lim="800000"/>
          </a:ln>
          <a:effectLst/>
        </p:spPr>
      </p:cxnSp>
      <p:cxnSp>
        <p:nvCxnSpPr>
          <p:cNvPr id="16" name="Gerade Verbindung 28">
            <a:extLst>
              <a:ext uri="{FF2B5EF4-FFF2-40B4-BE49-F238E27FC236}">
                <a16:creationId xmlns:a16="http://schemas.microsoft.com/office/drawing/2014/main" id="{CDC31324-CB87-4E1D-9C42-182EFF9CA5DD}"/>
              </a:ext>
            </a:extLst>
          </p:cNvPr>
          <p:cNvCxnSpPr>
            <a:cxnSpLocks/>
          </p:cNvCxnSpPr>
          <p:nvPr/>
        </p:nvCxnSpPr>
        <p:spPr>
          <a:xfrm>
            <a:off x="2998834" y="1449216"/>
            <a:ext cx="864000" cy="0"/>
          </a:xfrm>
          <a:prstGeom prst="line">
            <a:avLst/>
          </a:prstGeom>
          <a:noFill/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17" name="Textfeld 16">
            <a:extLst>
              <a:ext uri="{FF2B5EF4-FFF2-40B4-BE49-F238E27FC236}">
                <a16:creationId xmlns:a16="http://schemas.microsoft.com/office/drawing/2014/main" id="{072EBEAD-14DE-F850-1C99-59B846920CB8}"/>
              </a:ext>
            </a:extLst>
          </p:cNvPr>
          <p:cNvSpPr txBox="1"/>
          <p:nvPr/>
        </p:nvSpPr>
        <p:spPr>
          <a:xfrm>
            <a:off x="3132114" y="1245806"/>
            <a:ext cx="6158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de-DE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ron 2</a:t>
            </a:r>
          </a:p>
        </p:txBody>
      </p:sp>
      <p:cxnSp>
        <p:nvCxnSpPr>
          <p:cNvPr id="18" name="Gerade Verbindung 11">
            <a:extLst>
              <a:ext uri="{FF2B5EF4-FFF2-40B4-BE49-F238E27FC236}">
                <a16:creationId xmlns:a16="http://schemas.microsoft.com/office/drawing/2014/main" id="{A4312A21-6753-E34F-8A88-F52DB92D506B}"/>
              </a:ext>
            </a:extLst>
          </p:cNvPr>
          <p:cNvCxnSpPr>
            <a:cxnSpLocks/>
          </p:cNvCxnSpPr>
          <p:nvPr/>
        </p:nvCxnSpPr>
        <p:spPr>
          <a:xfrm flipH="1">
            <a:off x="481734" y="1841340"/>
            <a:ext cx="2646758" cy="405777"/>
          </a:xfrm>
          <a:prstGeom prst="line">
            <a:avLst/>
          </a:prstGeom>
          <a:noFill/>
          <a:ln w="6350" cap="flat" cmpd="sng" algn="ctr">
            <a:solidFill>
              <a:sysClr val="windowText" lastClr="000000">
                <a:lumMod val="75000"/>
                <a:lumOff val="25000"/>
              </a:sysClr>
            </a:solidFill>
            <a:prstDash val="solid"/>
            <a:miter lim="800000"/>
          </a:ln>
          <a:effectLst/>
        </p:spPr>
      </p:cxnSp>
      <p:cxnSp>
        <p:nvCxnSpPr>
          <p:cNvPr id="19" name="Gerade Verbindung 13">
            <a:extLst>
              <a:ext uri="{FF2B5EF4-FFF2-40B4-BE49-F238E27FC236}">
                <a16:creationId xmlns:a16="http://schemas.microsoft.com/office/drawing/2014/main" id="{9C438F14-0349-1825-ECF3-99A1EFA90B54}"/>
              </a:ext>
            </a:extLst>
          </p:cNvPr>
          <p:cNvCxnSpPr>
            <a:cxnSpLocks/>
          </p:cNvCxnSpPr>
          <p:nvPr/>
        </p:nvCxnSpPr>
        <p:spPr>
          <a:xfrm>
            <a:off x="3541960" y="1841340"/>
            <a:ext cx="2799885" cy="394932"/>
          </a:xfrm>
          <a:prstGeom prst="line">
            <a:avLst/>
          </a:prstGeom>
          <a:noFill/>
          <a:ln w="6350" cap="flat" cmpd="sng" algn="ctr">
            <a:solidFill>
              <a:sysClr val="windowText" lastClr="000000">
                <a:lumMod val="75000"/>
                <a:lumOff val="25000"/>
              </a:sysClr>
            </a:solidFill>
            <a:prstDash val="solid"/>
            <a:miter lim="800000"/>
          </a:ln>
          <a:effectLst/>
        </p:spPr>
      </p:cxnSp>
      <p:sp>
        <p:nvSpPr>
          <p:cNvPr id="20" name="Textfeld 19">
            <a:extLst>
              <a:ext uri="{FF2B5EF4-FFF2-40B4-BE49-F238E27FC236}">
                <a16:creationId xmlns:a16="http://schemas.microsoft.com/office/drawing/2014/main" id="{0C606E34-0394-CBAB-8ED7-F6FF4E3F574B}"/>
              </a:ext>
            </a:extLst>
          </p:cNvPr>
          <p:cNvSpPr txBox="1"/>
          <p:nvPr/>
        </p:nvSpPr>
        <p:spPr>
          <a:xfrm>
            <a:off x="258546" y="308133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71A2E556-1DE3-DF01-2F90-4CE9A025A38A}"/>
              </a:ext>
            </a:extLst>
          </p:cNvPr>
          <p:cNvSpPr txBox="1"/>
          <p:nvPr/>
        </p:nvSpPr>
        <p:spPr>
          <a:xfrm>
            <a:off x="119643" y="191565"/>
            <a:ext cx="59554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S2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linical samples sequencing for premature stop codon in CE4</a:t>
            </a:r>
          </a:p>
        </p:txBody>
      </p:sp>
    </p:spTree>
    <p:extLst>
      <p:ext uri="{BB962C8B-B14F-4D97-AF65-F5344CB8AC3E}">
        <p14:creationId xmlns:p14="http://schemas.microsoft.com/office/powerpoint/2010/main" val="7041121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67</Words>
  <Application>Microsoft Macintosh PowerPoint</Application>
  <PresentationFormat>Benutzerdefiniert</PresentationFormat>
  <Paragraphs>28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üstmann, Neele Elisabeth</dc:creator>
  <cp:lastModifiedBy>Christof Bernemann</cp:lastModifiedBy>
  <cp:revision>169</cp:revision>
  <dcterms:created xsi:type="dcterms:W3CDTF">2023-07-26T11:31:58Z</dcterms:created>
  <dcterms:modified xsi:type="dcterms:W3CDTF">2024-06-12T10:08:13Z</dcterms:modified>
</cp:coreProperties>
</file>